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442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0037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169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976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594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87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5794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616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3355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5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690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2999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123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1754" y="279576"/>
            <a:ext cx="4630436" cy="636685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3807330" y="4982532"/>
            <a:ext cx="100380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4836992" y="4334346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3919540" y="4436546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直角三角形 6"/>
          <p:cNvSpPr/>
          <p:nvPr/>
        </p:nvSpPr>
        <p:spPr>
          <a:xfrm flipH="1">
            <a:off x="4978400" y="4512800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3635808" y="4698052"/>
            <a:ext cx="1175323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 flipV="1">
            <a:off x="4730697" y="4911769"/>
            <a:ext cx="1524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 10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809723" y="4067214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4956903" y="4384006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矩形 14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941673" y="1601328"/>
            <a:ext cx="100380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7002398" y="5182586"/>
            <a:ext cx="609986" cy="276999"/>
            <a:chOff x="-5698802" y="6919617"/>
            <a:chExt cx="609986" cy="276999"/>
          </a:xfrm>
        </p:grpSpPr>
        <p:sp>
          <p:nvSpPr>
            <p:cNvPr id="18" name="矩形 17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" name="组合 19"/>
          <p:cNvGrpSpPr/>
          <p:nvPr/>
        </p:nvGrpSpPr>
        <p:grpSpPr>
          <a:xfrm>
            <a:off x="7014466" y="4637281"/>
            <a:ext cx="609986" cy="276999"/>
            <a:chOff x="-5698802" y="6919617"/>
            <a:chExt cx="609986" cy="276999"/>
          </a:xfrm>
        </p:grpSpPr>
        <p:sp>
          <p:nvSpPr>
            <p:cNvPr id="21" name="矩形 20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" name="矩形 9"/>
          <p:cNvSpPr/>
          <p:nvPr/>
        </p:nvSpPr>
        <p:spPr>
          <a:xfrm>
            <a:off x="4836992" y="4775781"/>
            <a:ext cx="1567896" cy="683804"/>
          </a:xfrm>
          <a:prstGeom prst="rect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682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5733" y="337158"/>
            <a:ext cx="4631564" cy="636840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878037" y="3992242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025217" y="4309034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直角三角形 11"/>
          <p:cNvSpPr/>
          <p:nvPr/>
        </p:nvSpPr>
        <p:spPr>
          <a:xfrm flipH="1">
            <a:off x="5009395" y="4475406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7238006" y="4762498"/>
            <a:ext cx="609986" cy="276999"/>
            <a:chOff x="-5698802" y="6919617"/>
            <a:chExt cx="609986" cy="276999"/>
          </a:xfrm>
        </p:grpSpPr>
        <p:sp>
          <p:nvSpPr>
            <p:cNvPr id="14" name="矩形 13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" name="组合 15"/>
          <p:cNvGrpSpPr/>
          <p:nvPr/>
        </p:nvGrpSpPr>
        <p:grpSpPr>
          <a:xfrm>
            <a:off x="7234147" y="4361574"/>
            <a:ext cx="609986" cy="276999"/>
            <a:chOff x="-5698802" y="6919617"/>
            <a:chExt cx="609986" cy="276999"/>
          </a:xfrm>
        </p:grpSpPr>
        <p:sp>
          <p:nvSpPr>
            <p:cNvPr id="17" name="矩形 16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矩形 18"/>
          <p:cNvSpPr/>
          <p:nvPr/>
        </p:nvSpPr>
        <p:spPr>
          <a:xfrm>
            <a:off x="1218069" y="582157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4071098" y="4391438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4904924" y="4744323"/>
            <a:ext cx="1567896" cy="464545"/>
          </a:xfrm>
          <a:prstGeom prst="rect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3178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0937" y="26126"/>
            <a:ext cx="4631564" cy="63684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346052" y="4436545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5106285" y="4053128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253465" y="4369920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5237643" y="4536292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7288830" y="4927901"/>
            <a:ext cx="609986" cy="276999"/>
            <a:chOff x="-5698802" y="6919617"/>
            <a:chExt cx="609986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7288830" y="4590434"/>
            <a:ext cx="609986" cy="276999"/>
            <a:chOff x="-5698802" y="6919617"/>
            <a:chExt cx="609986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矩形 16"/>
          <p:cNvSpPr/>
          <p:nvPr/>
        </p:nvSpPr>
        <p:spPr>
          <a:xfrm>
            <a:off x="1474548" y="582157"/>
            <a:ext cx="748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5124544" y="4791343"/>
            <a:ext cx="1625841" cy="394993"/>
          </a:xfrm>
          <a:prstGeom prst="rect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00570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6203" y="-267041"/>
            <a:ext cx="4631564" cy="63684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253861" y="4453918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5106285" y="4053128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253465" y="4369920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直角三角形 8"/>
          <p:cNvSpPr/>
          <p:nvPr/>
        </p:nvSpPr>
        <p:spPr>
          <a:xfrm flipH="1">
            <a:off x="5237643" y="4536292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7288830" y="4927901"/>
            <a:ext cx="609986" cy="276999"/>
            <a:chOff x="-5698802" y="6919617"/>
            <a:chExt cx="609986" cy="276999"/>
          </a:xfrm>
        </p:grpSpPr>
        <p:sp>
          <p:nvSpPr>
            <p:cNvPr id="11" name="矩形 10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" name="组合 12"/>
          <p:cNvGrpSpPr/>
          <p:nvPr/>
        </p:nvGrpSpPr>
        <p:grpSpPr>
          <a:xfrm>
            <a:off x="7288830" y="4590434"/>
            <a:ext cx="609986" cy="276999"/>
            <a:chOff x="-5698802" y="6919617"/>
            <a:chExt cx="609986" cy="276999"/>
          </a:xfrm>
        </p:grpSpPr>
        <p:sp>
          <p:nvSpPr>
            <p:cNvPr id="14" name="矩形 13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矩形 15"/>
          <p:cNvSpPr/>
          <p:nvPr/>
        </p:nvSpPr>
        <p:spPr>
          <a:xfrm>
            <a:off x="1423253" y="582157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5106285" y="4809907"/>
            <a:ext cx="1625841" cy="394993"/>
          </a:xfrm>
          <a:prstGeom prst="rect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8593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6021" y="373039"/>
            <a:ext cx="4631564" cy="63684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961587" y="582157"/>
            <a:ext cx="12618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ho-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427762" y="5250340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5319353" y="4919412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466533" y="5236204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5381261" y="5286826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7432448" y="5724735"/>
            <a:ext cx="609986" cy="276999"/>
            <a:chOff x="-5698802" y="6919617"/>
            <a:chExt cx="609986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7432448" y="5387268"/>
            <a:ext cx="609986" cy="276999"/>
            <a:chOff x="-5698802" y="6919617"/>
            <a:chExt cx="609986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矩形 17"/>
          <p:cNvSpPr/>
          <p:nvPr/>
        </p:nvSpPr>
        <p:spPr>
          <a:xfrm>
            <a:off x="5245732" y="5617697"/>
            <a:ext cx="1625841" cy="394993"/>
          </a:xfrm>
          <a:prstGeom prst="rect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6459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5758" y="346913"/>
            <a:ext cx="4631564" cy="63684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230892" y="582157"/>
            <a:ext cx="992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954093" y="3267196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749051" y="2894670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4896231" y="3211462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4845684" y="3308384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6922997" y="3989544"/>
            <a:ext cx="694945" cy="276999"/>
            <a:chOff x="-5698802" y="6919617"/>
            <a:chExt cx="694945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矩形 17"/>
          <p:cNvSpPr/>
          <p:nvPr/>
        </p:nvSpPr>
        <p:spPr>
          <a:xfrm>
            <a:off x="4684294" y="3618379"/>
            <a:ext cx="1625841" cy="394993"/>
          </a:xfrm>
          <a:prstGeom prst="rect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72057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2879" y="281599"/>
            <a:ext cx="4631564" cy="63684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769228" y="582157"/>
            <a:ext cx="14542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ho-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751042" y="4298948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644549" y="3929616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4791729" y="4246408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4741182" y="4237830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6818495" y="5047635"/>
            <a:ext cx="694945" cy="276999"/>
            <a:chOff x="-5698802" y="6919617"/>
            <a:chExt cx="694945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" name="矩形 14"/>
          <p:cNvSpPr/>
          <p:nvPr/>
        </p:nvSpPr>
        <p:spPr>
          <a:xfrm>
            <a:off x="4597619" y="4695343"/>
            <a:ext cx="1625841" cy="394993"/>
          </a:xfrm>
          <a:prstGeom prst="rect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727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47</Words>
  <Application>Microsoft Office PowerPoint</Application>
  <PresentationFormat>宽屏</PresentationFormat>
  <Paragraphs>35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10</cp:revision>
  <dcterms:created xsi:type="dcterms:W3CDTF">2024-02-08T02:44:39Z</dcterms:created>
  <dcterms:modified xsi:type="dcterms:W3CDTF">2024-03-05T12:58:53Z</dcterms:modified>
</cp:coreProperties>
</file>